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A50A02-6F46-4C28-ABB5-6D303073137E}" v="2" dt="2024-11-10T18:19:03.07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159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hosh, Souvik" userId="eecea02d-3ead-4d19-9bc6-c58aca595acd" providerId="ADAL" clId="{3EA50A02-6F46-4C28-ABB5-6D303073137E}"/>
    <pc:docChg chg="undo custSel addSld modSld modMainMaster">
      <pc:chgData name="Ghosh, Souvik" userId="eecea02d-3ead-4d19-9bc6-c58aca595acd" providerId="ADAL" clId="{3EA50A02-6F46-4C28-ABB5-6D303073137E}" dt="2024-11-10T18:19:27.462" v="18" actId="20577"/>
      <pc:docMkLst>
        <pc:docMk/>
      </pc:docMkLst>
      <pc:sldChg chg="addSp delSp modSp new mod setBg">
        <pc:chgData name="Ghosh, Souvik" userId="eecea02d-3ead-4d19-9bc6-c58aca595acd" providerId="ADAL" clId="{3EA50A02-6F46-4C28-ABB5-6D303073137E}" dt="2024-11-10T18:19:27.462" v="18" actId="20577"/>
        <pc:sldMkLst>
          <pc:docMk/>
          <pc:sldMk cId="2596315072" sldId="256"/>
        </pc:sldMkLst>
        <pc:spChg chg="add mod">
          <ac:chgData name="Ghosh, Souvik" userId="eecea02d-3ead-4d19-9bc6-c58aca595acd" providerId="ADAL" clId="{3EA50A02-6F46-4C28-ABB5-6D303073137E}" dt="2024-11-10T18:19:27.462" v="18" actId="20577"/>
          <ac:spMkLst>
            <pc:docMk/>
            <pc:sldMk cId="2596315072" sldId="256"/>
            <ac:spMk id="3" creationId="{DAE3780E-C85D-5B1B-DB9F-BA2BB560F759}"/>
          </ac:spMkLst>
        </pc:spChg>
        <pc:spChg chg="add del">
          <ac:chgData name="Ghosh, Souvik" userId="eecea02d-3ead-4d19-9bc6-c58aca595acd" providerId="ADAL" clId="{3EA50A02-6F46-4C28-ABB5-6D303073137E}" dt="2024-11-10T18:19:07.415" v="17" actId="26606"/>
          <ac:spMkLst>
            <pc:docMk/>
            <pc:sldMk cId="2596315072" sldId="256"/>
            <ac:spMk id="10" creationId="{2B97F24A-32CE-4C1C-A50D-3016B394DCFB}"/>
          </ac:spMkLst>
        </pc:spChg>
        <pc:spChg chg="add del">
          <ac:chgData name="Ghosh, Souvik" userId="eecea02d-3ead-4d19-9bc6-c58aca595acd" providerId="ADAL" clId="{3EA50A02-6F46-4C28-ABB5-6D303073137E}" dt="2024-11-10T18:19:07.415" v="17" actId="26606"/>
          <ac:spMkLst>
            <pc:docMk/>
            <pc:sldMk cId="2596315072" sldId="256"/>
            <ac:spMk id="12" creationId="{CD8B4F24-440B-49E9-B85D-733523DC064B}"/>
          </ac:spMkLst>
        </pc:spChg>
        <pc:picChg chg="add mod">
          <ac:chgData name="Ghosh, Souvik" userId="eecea02d-3ead-4d19-9bc6-c58aca595acd" providerId="ADAL" clId="{3EA50A02-6F46-4C28-ABB5-6D303073137E}" dt="2024-11-10T18:19:07.415" v="17" actId="26606"/>
          <ac:picMkLst>
            <pc:docMk/>
            <pc:sldMk cId="2596315072" sldId="256"/>
            <ac:picMk id="5" creationId="{876CCC09-1C24-7D87-36AB-8AEF57F4738C}"/>
          </ac:picMkLst>
        </pc:picChg>
      </pc:sldChg>
      <pc:sldMasterChg chg="modSp modSldLayout">
        <pc:chgData name="Ghosh, Souvik" userId="eecea02d-3ead-4d19-9bc6-c58aca595acd" providerId="ADAL" clId="{3EA50A02-6F46-4C28-ABB5-6D303073137E}" dt="2024-11-10T18:17:36.316" v="0"/>
        <pc:sldMasterMkLst>
          <pc:docMk/>
          <pc:sldMasterMk cId="1822577467" sldId="2147483648"/>
        </pc:sldMasterMkLst>
        <pc:spChg chg="mod">
          <ac:chgData name="Ghosh, Souvik" userId="eecea02d-3ead-4d19-9bc6-c58aca595acd" providerId="ADAL" clId="{3EA50A02-6F46-4C28-ABB5-6D303073137E}" dt="2024-11-10T18:17:36.316" v="0"/>
          <ac:spMkLst>
            <pc:docMk/>
            <pc:sldMasterMk cId="1822577467" sldId="2147483648"/>
            <ac:spMk id="2" creationId="{EE0B029D-C6A1-6C42-1236-EC543193217A}"/>
          </ac:spMkLst>
        </pc:spChg>
        <pc:spChg chg="mod">
          <ac:chgData name="Ghosh, Souvik" userId="eecea02d-3ead-4d19-9bc6-c58aca595acd" providerId="ADAL" clId="{3EA50A02-6F46-4C28-ABB5-6D303073137E}" dt="2024-11-10T18:17:36.316" v="0"/>
          <ac:spMkLst>
            <pc:docMk/>
            <pc:sldMasterMk cId="1822577467" sldId="2147483648"/>
            <ac:spMk id="3" creationId="{ABF89AF2-3865-699D-8AB9-EEFAE41A0CEF}"/>
          </ac:spMkLst>
        </pc:spChg>
        <pc:spChg chg="mod">
          <ac:chgData name="Ghosh, Souvik" userId="eecea02d-3ead-4d19-9bc6-c58aca595acd" providerId="ADAL" clId="{3EA50A02-6F46-4C28-ABB5-6D303073137E}" dt="2024-11-10T18:17:36.316" v="0"/>
          <ac:spMkLst>
            <pc:docMk/>
            <pc:sldMasterMk cId="1822577467" sldId="2147483648"/>
            <ac:spMk id="4" creationId="{6117D9F2-D27E-7AC8-7E5E-39CB0E266E3C}"/>
          </ac:spMkLst>
        </pc:spChg>
        <pc:spChg chg="mod">
          <ac:chgData name="Ghosh, Souvik" userId="eecea02d-3ead-4d19-9bc6-c58aca595acd" providerId="ADAL" clId="{3EA50A02-6F46-4C28-ABB5-6D303073137E}" dt="2024-11-10T18:17:36.316" v="0"/>
          <ac:spMkLst>
            <pc:docMk/>
            <pc:sldMasterMk cId="1822577467" sldId="2147483648"/>
            <ac:spMk id="5" creationId="{F61C6B27-D3A3-0FF4-412C-571A43719C3C}"/>
          </ac:spMkLst>
        </pc:spChg>
        <pc:spChg chg="mod">
          <ac:chgData name="Ghosh, Souvik" userId="eecea02d-3ead-4d19-9bc6-c58aca595acd" providerId="ADAL" clId="{3EA50A02-6F46-4C28-ABB5-6D303073137E}" dt="2024-11-10T18:17:36.316" v="0"/>
          <ac:spMkLst>
            <pc:docMk/>
            <pc:sldMasterMk cId="1822577467" sldId="2147483648"/>
            <ac:spMk id="6" creationId="{235A2509-9C41-85AA-A402-74A9CBC294F9}"/>
          </ac:spMkLst>
        </pc:spChg>
        <pc:sldLayoutChg chg="modSp">
          <pc:chgData name="Ghosh, Souvik" userId="eecea02d-3ead-4d19-9bc6-c58aca595acd" providerId="ADAL" clId="{3EA50A02-6F46-4C28-ABB5-6D303073137E}" dt="2024-11-10T18:17:36.316" v="0"/>
          <pc:sldLayoutMkLst>
            <pc:docMk/>
            <pc:sldMasterMk cId="1822577467" sldId="2147483648"/>
            <pc:sldLayoutMk cId="1986253797" sldId="2147483649"/>
          </pc:sldLayoutMkLst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1986253797" sldId="2147483649"/>
              <ac:spMk id="2" creationId="{6791263E-B210-76FD-45F3-DB1E8BDAF6B7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1986253797" sldId="2147483649"/>
              <ac:spMk id="3" creationId="{EFD78A36-7BB2-56BB-183F-A1207ABDA69D}"/>
            </ac:spMkLst>
          </pc:spChg>
        </pc:sldLayoutChg>
        <pc:sldLayoutChg chg="modSp">
          <pc:chgData name="Ghosh, Souvik" userId="eecea02d-3ead-4d19-9bc6-c58aca595acd" providerId="ADAL" clId="{3EA50A02-6F46-4C28-ABB5-6D303073137E}" dt="2024-11-10T18:17:36.316" v="0"/>
          <pc:sldLayoutMkLst>
            <pc:docMk/>
            <pc:sldMasterMk cId="1822577467" sldId="2147483648"/>
            <pc:sldLayoutMk cId="2753913489" sldId="2147483651"/>
          </pc:sldLayoutMkLst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2753913489" sldId="2147483651"/>
              <ac:spMk id="2" creationId="{5196FEC8-CF4C-4786-DBAE-228302383970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2753913489" sldId="2147483651"/>
              <ac:spMk id="3" creationId="{B9551E20-D362-B977-AB64-C5460FF425EB}"/>
            </ac:spMkLst>
          </pc:spChg>
        </pc:sldLayoutChg>
        <pc:sldLayoutChg chg="modSp">
          <pc:chgData name="Ghosh, Souvik" userId="eecea02d-3ead-4d19-9bc6-c58aca595acd" providerId="ADAL" clId="{3EA50A02-6F46-4C28-ABB5-6D303073137E}" dt="2024-11-10T18:17:36.316" v="0"/>
          <pc:sldLayoutMkLst>
            <pc:docMk/>
            <pc:sldMasterMk cId="1822577467" sldId="2147483648"/>
            <pc:sldLayoutMk cId="2867510801" sldId="2147483652"/>
          </pc:sldLayoutMkLst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2867510801" sldId="2147483652"/>
              <ac:spMk id="3" creationId="{2F54574C-50EE-F078-0A4E-0BA3319D190D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2867510801" sldId="2147483652"/>
              <ac:spMk id="4" creationId="{8C911E35-97B0-54BE-88E2-ADB854270D98}"/>
            </ac:spMkLst>
          </pc:spChg>
        </pc:sldLayoutChg>
        <pc:sldLayoutChg chg="modSp">
          <pc:chgData name="Ghosh, Souvik" userId="eecea02d-3ead-4d19-9bc6-c58aca595acd" providerId="ADAL" clId="{3EA50A02-6F46-4C28-ABB5-6D303073137E}" dt="2024-11-10T18:17:36.316" v="0"/>
          <pc:sldLayoutMkLst>
            <pc:docMk/>
            <pc:sldMasterMk cId="1822577467" sldId="2147483648"/>
            <pc:sldLayoutMk cId="882324378" sldId="2147483653"/>
          </pc:sldLayoutMkLst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882324378" sldId="2147483653"/>
              <ac:spMk id="2" creationId="{BD8E0785-ED12-EE7E-8340-2908D0653338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882324378" sldId="2147483653"/>
              <ac:spMk id="3" creationId="{A9D7C712-D886-B0CA-0F00-79FE1FC99A6B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882324378" sldId="2147483653"/>
              <ac:spMk id="4" creationId="{069B816E-0DE5-78F8-A506-1D823767CCD0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882324378" sldId="2147483653"/>
              <ac:spMk id="5" creationId="{B3A9AC19-D3E4-1C2C-66E4-0F75849A8039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882324378" sldId="2147483653"/>
              <ac:spMk id="6" creationId="{B507608F-32AF-CC1B-BF3B-39FD6918115A}"/>
            </ac:spMkLst>
          </pc:spChg>
        </pc:sldLayoutChg>
        <pc:sldLayoutChg chg="modSp">
          <pc:chgData name="Ghosh, Souvik" userId="eecea02d-3ead-4d19-9bc6-c58aca595acd" providerId="ADAL" clId="{3EA50A02-6F46-4C28-ABB5-6D303073137E}" dt="2024-11-10T18:17:36.316" v="0"/>
          <pc:sldLayoutMkLst>
            <pc:docMk/>
            <pc:sldMasterMk cId="1822577467" sldId="2147483648"/>
            <pc:sldLayoutMk cId="2975559138" sldId="2147483656"/>
          </pc:sldLayoutMkLst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2975559138" sldId="2147483656"/>
              <ac:spMk id="2" creationId="{12847362-87E9-78C0-1ADC-5785D5BDA4F6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2975559138" sldId="2147483656"/>
              <ac:spMk id="3" creationId="{CED2DD07-9F95-8C81-5B69-E2EB9E2BF8BB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2975559138" sldId="2147483656"/>
              <ac:spMk id="4" creationId="{D362C754-4EEB-BA55-96CC-358C48A7466F}"/>
            </ac:spMkLst>
          </pc:spChg>
        </pc:sldLayoutChg>
        <pc:sldLayoutChg chg="modSp">
          <pc:chgData name="Ghosh, Souvik" userId="eecea02d-3ead-4d19-9bc6-c58aca595acd" providerId="ADAL" clId="{3EA50A02-6F46-4C28-ABB5-6D303073137E}" dt="2024-11-10T18:17:36.316" v="0"/>
          <pc:sldLayoutMkLst>
            <pc:docMk/>
            <pc:sldMasterMk cId="1822577467" sldId="2147483648"/>
            <pc:sldLayoutMk cId="3302570202" sldId="2147483657"/>
          </pc:sldLayoutMkLst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3302570202" sldId="2147483657"/>
              <ac:spMk id="2" creationId="{DABEFE1E-DCFE-9204-5B58-E967AA713015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3302570202" sldId="2147483657"/>
              <ac:spMk id="3" creationId="{BD52953A-0E68-E258-56D8-DF77BB5566DB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3302570202" sldId="2147483657"/>
              <ac:spMk id="4" creationId="{061F73AC-19E3-F523-CC9C-F2BEF4A5C311}"/>
            </ac:spMkLst>
          </pc:spChg>
        </pc:sldLayoutChg>
        <pc:sldLayoutChg chg="modSp">
          <pc:chgData name="Ghosh, Souvik" userId="eecea02d-3ead-4d19-9bc6-c58aca595acd" providerId="ADAL" clId="{3EA50A02-6F46-4C28-ABB5-6D303073137E}" dt="2024-11-10T18:17:36.316" v="0"/>
          <pc:sldLayoutMkLst>
            <pc:docMk/>
            <pc:sldMasterMk cId="1822577467" sldId="2147483648"/>
            <pc:sldLayoutMk cId="1106178605" sldId="2147483659"/>
          </pc:sldLayoutMkLst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1106178605" sldId="2147483659"/>
              <ac:spMk id="2" creationId="{3D42C103-0BA7-709A-DD51-00B51C46846F}"/>
            </ac:spMkLst>
          </pc:spChg>
          <pc:spChg chg="mod">
            <ac:chgData name="Ghosh, Souvik" userId="eecea02d-3ead-4d19-9bc6-c58aca595acd" providerId="ADAL" clId="{3EA50A02-6F46-4C28-ABB5-6D303073137E}" dt="2024-11-10T18:17:36.316" v="0"/>
            <ac:spMkLst>
              <pc:docMk/>
              <pc:sldMasterMk cId="1822577467" sldId="2147483648"/>
              <pc:sldLayoutMk cId="1106178605" sldId="2147483659"/>
              <ac:spMk id="3" creationId="{0CF704BA-E501-677C-FA8E-4CC3EA78D661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91263E-B210-76FD-45F3-DB1E8BDAF6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FD78A36-7BB2-56BB-183F-A1207ABDA6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89971B-EA45-09DB-A49A-DDC507294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F1B2C8-E184-C04C-7134-775466812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5A8A5-8860-3BEB-2D81-E0A676CA4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253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C89E6-7FEF-7F77-D5F7-964FB578E5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3E880E-202D-3268-045A-B76D6E2309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0F7568-C2F6-6733-F17F-C769863AC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29BFAA-0BF8-12B7-32EC-7666DDCEA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15EA3D-6144-E00F-6893-F5DC737FC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367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42C103-0BA7-709A-DD51-00B51C4684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F704BA-E501-677C-FA8E-4CC3EA78D6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26605-05FB-2AAF-35EE-FFAA66CAB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E9A616-2011-C43B-9DD9-C99D5AD78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25AF1A-AABB-948A-E1E7-C32DD66E4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178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867AB6-A7D7-E490-9B44-264EA05CC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025E2D-F5DE-B1B6-7469-70048DBDC6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AEE168-2378-6671-6B6B-8FA197AF8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6FF623-A5DF-5858-5689-0C26A5FD4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2A4A52-8331-6A6A-6D14-E11C5F9A2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43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96FEC8-CF4C-4786-DBAE-2283023839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551E20-D362-B977-AB64-C5460FF425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1F1960-AABD-F638-3E68-11FDB4A26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7ECEAC-EA2A-E7CE-B50D-34C932652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4A8D2B-02E7-D368-935B-44F57C213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913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6FCCC-DEA0-0580-D1A6-A5FBE9AA68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54574C-50EE-F078-0A4E-0BA3319D19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911E35-97B0-54BE-88E2-ADB854270D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D8D4A4-B58E-9B16-0CE2-D9B5D5BB7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B1AFEE-E53C-F0AB-7104-F6693A43B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70D8AE-4B74-F66B-900B-67979ADC3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510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8E0785-ED12-EE7E-8340-2908D06533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D7C712-D886-B0CA-0F00-79FE1FC99A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9B816E-0DE5-78F8-A506-1D823767CC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3A9AC19-D3E4-1C2C-66E4-0F75849A80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07608F-32AF-CC1B-BF3B-39FD691811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F95E78-47DB-D77C-6C1B-D622B284C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77BB48-5187-4A3E-811B-E3FE7FA15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15E868-2500-BAE6-288C-57F80C3A4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324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7076A-628C-522B-B313-59CF18F149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E8D9DE-BDE4-1106-9C20-74A74CB70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CFDF754-E909-DD51-62B5-0FF1AD111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3F8A2D0-E0AC-FE29-68D4-8E02CA900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542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EEE835-6B4E-A4F4-1B84-91F61035A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6352A4-A452-390A-25B1-B896347B78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53023B-6179-E5EC-5538-0B3B25E35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579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47362-87E9-78C0-1ADC-5785D5BDA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D2DD07-9F95-8C81-5B69-E2EB9E2BF8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62C754-4EEB-BA55-96CC-358C48A746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AAE14B-7D79-6D73-E61E-8AB710644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C36E6A-4190-EF0B-670D-C30EC59C5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14A3CC-DEA1-8D9F-5B50-64A908968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559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EFE1E-DCFE-9204-5B58-E967AA7130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52953A-0E68-E258-56D8-DF77BB5566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1F73AC-19E3-F523-CC9C-F2BEF4A5C3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A8037E-7D42-C02E-04E8-7EE05EA39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20C4C6-A70F-6711-6ADC-2D2CA8794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E5F04B-91B9-E7CD-14BA-B4597F050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570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0B029D-C6A1-6C42-1236-EC54319321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F89AF2-3865-699D-8AB9-EEFAE41A0C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17D9F2-D27E-7AC8-7E5E-39CB0E266E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38F137-CC28-449B-90F3-FABF932D626E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1C6B27-D3A3-0FF4-412C-571A43719C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5A2509-9C41-85AA-A402-74A9CBC294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12EA4D-DB08-4A6B-A7A1-1017817E89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577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AE3780E-C85D-5B1B-DB9F-BA2BB560F759}"/>
              </a:ext>
            </a:extLst>
          </p:cNvPr>
          <p:cNvSpPr txBox="1"/>
          <p:nvPr/>
        </p:nvSpPr>
        <p:spPr>
          <a:xfrm>
            <a:off x="152400" y="153521"/>
            <a:ext cx="875792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Supplementary figure S1. </a:t>
            </a:r>
            <a:r>
              <a:rPr lang="en-US" sz="1200" dirty="0">
                <a:latin typeface="Palatino Linotype" panose="02040502050505030304" pitchFamily="18" charset="0"/>
              </a:rPr>
              <a:t>Phylogenetic analysis of the partial DPOL CDS (~ 200 </a:t>
            </a:r>
            <a:r>
              <a:rPr lang="en-US" sz="1200" dirty="0" err="1">
                <a:latin typeface="Palatino Linotype" panose="02040502050505030304" pitchFamily="18" charset="0"/>
              </a:rPr>
              <a:t>nt</a:t>
            </a:r>
            <a:r>
              <a:rPr lang="en-US" sz="1200" dirty="0">
                <a:latin typeface="Palatino Linotype" panose="02040502050505030304" pitchFamily="18" charset="0"/>
              </a:rPr>
              <a:t>) of the bat herpesviruses from St. Kitts. The BO group-I and -II herpesviruses are shown with red and blue circles, respectively, whilst the single BO-I </a:t>
            </a:r>
            <a:r>
              <a:rPr lang="en-US" sz="1200" i="1" dirty="0">
                <a:latin typeface="Palatino Linotype" panose="02040502050505030304" pitchFamily="18" charset="0"/>
              </a:rPr>
              <a:t>Molossus </a:t>
            </a:r>
            <a:r>
              <a:rPr lang="en-US" sz="1200" i="1" dirty="0" err="1">
                <a:latin typeface="Palatino Linotype" panose="02040502050505030304" pitchFamily="18" charset="0"/>
              </a:rPr>
              <a:t>molossus</a:t>
            </a:r>
            <a:r>
              <a:rPr lang="en-US" sz="1200" dirty="0">
                <a:latin typeface="Palatino Linotype" panose="02040502050505030304" pitchFamily="18" charset="0"/>
              </a:rPr>
              <a:t> herpesvirus is indicated with an arrow. The 'name of the virus/bat-species/year of sampling' has been mentioned for the BO herpesviruses. Bootstrap values &lt; 70% are not shown. Scale bar, 2 substitutions per </a:t>
            </a:r>
            <a:r>
              <a:rPr lang="en-US" sz="1200" dirty="0" err="1">
                <a:latin typeface="Palatino Linotype" panose="02040502050505030304" pitchFamily="18" charset="0"/>
              </a:rPr>
              <a:t>nt</a:t>
            </a:r>
            <a:r>
              <a:rPr lang="en-US" sz="1200" dirty="0">
                <a:latin typeface="Palatino Linotype" panose="02040502050505030304" pitchFamily="18" charset="0"/>
              </a:rPr>
              <a:t> residue. Abbreviations: CDS, coding sequence; DPOL, DNA polymerase; </a:t>
            </a:r>
            <a:r>
              <a:rPr lang="en-US" sz="1200" dirty="0" err="1">
                <a:latin typeface="Palatino Linotype" panose="02040502050505030304" pitchFamily="18" charset="0"/>
              </a:rPr>
              <a:t>nt</a:t>
            </a:r>
            <a:r>
              <a:rPr lang="en-US" sz="1200" dirty="0">
                <a:latin typeface="Palatino Linotype" panose="02040502050505030304" pitchFamily="18" charset="0"/>
              </a:rPr>
              <a:t>: nucleotide.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76CCC09-1C24-7D87-36AB-8AEF57F473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967" y="1540625"/>
            <a:ext cx="7728065" cy="3776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6315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hosh, Souvik</dc:creator>
  <cp:lastModifiedBy>Ghosh, Souvik</cp:lastModifiedBy>
  <cp:revision>1</cp:revision>
  <dcterms:created xsi:type="dcterms:W3CDTF">2024-11-10T18:17:31Z</dcterms:created>
  <dcterms:modified xsi:type="dcterms:W3CDTF">2024-11-10T18:19:30Z</dcterms:modified>
</cp:coreProperties>
</file>